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9305925" cy="70199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34" y="-17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597819"/>
            <a:ext cx="10363200" cy="11025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2914650"/>
            <a:ext cx="85344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9EE924-D2A5-422C-9D64-E7229F6498CA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3E66C7-FF05-4EE3-93AF-9B55C3D8D1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5B2B3F-946C-4D9F-893C-017047665F68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E7746C-EB02-4DE6-8315-65BFD6BB7DA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05979"/>
            <a:ext cx="2743200" cy="438864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05979"/>
            <a:ext cx="8026400" cy="438864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1AD562-A858-41C5-A94D-E1BB5E6DE89A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AF01BA-5ECE-486F-816E-39A841AEBC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A2CEFE-6E66-4DE4-9097-5D5CE12E907C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B09576-0617-43FF-94FC-EC08B0EC0C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3305176"/>
            <a:ext cx="103632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180035"/>
            <a:ext cx="103632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F42851-C4C5-48F5-AB81-3F0255794C38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976EF3-ECC6-4D27-8B8F-20EDE1415CC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200151"/>
            <a:ext cx="53848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200151"/>
            <a:ext cx="53848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816F19-8535-47B6-AA7C-BA4FB164B211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351121-601A-4214-8E0F-B512D1FFAB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151335"/>
            <a:ext cx="5386917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1631156"/>
            <a:ext cx="5386917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151335"/>
            <a:ext cx="5389033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1631156"/>
            <a:ext cx="5389033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7848B6-805B-406A-B04E-7B5EEDEED3BE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579856-E27C-4A64-808D-41B626BF890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AA54F6-6132-427D-91F1-E0C6FADE81A0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F6B526-2127-4596-B0D2-931F73520F7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8A33A0-D430-403F-8D37-E59FB084B2B2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D71297-F3F2-481B-BB9D-BCE86DA4EEF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04787"/>
            <a:ext cx="4011084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04788"/>
            <a:ext cx="6815667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076326"/>
            <a:ext cx="4011084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D2F5A1-1826-4D90-9691-48E5A12B5592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BFD70D-14DA-4D69-937E-3FB4264073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3600450"/>
            <a:ext cx="73152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459581"/>
            <a:ext cx="7315200" cy="30861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4025503"/>
            <a:ext cx="73152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8E45A5-C659-486E-85A4-D1378DAF6F34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0CBDED-3966-4F1D-A6B1-37F09B030FD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5035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5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43E37341-930C-48F4-818E-A7ED0B44F836}" type="datetimeFigureOut">
              <a:rPr lang="en-US"/>
              <a:pPr>
                <a:defRPr/>
              </a:pPr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748"/>
            <a:ext cx="2895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748"/>
            <a:ext cx="2133600" cy="36433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CB17298-02C1-4494-9DF9-A91ECD39CA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39" name="TextBox 14"/>
          <p:cNvSpPr txBox="1">
            <a:spLocks noChangeArrowheads="1"/>
          </p:cNvSpPr>
          <p:nvPr/>
        </p:nvSpPr>
        <p:spPr bwMode="auto">
          <a:xfrm rot="16200000">
            <a:off x="2327796" y="1437397"/>
            <a:ext cx="597717" cy="198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Calibri" pitchFamily="-72" charset="0"/>
              </a:rPr>
              <a:t>FISH</a:t>
            </a:r>
          </a:p>
        </p:txBody>
      </p:sp>
      <p:sp>
        <p:nvSpPr>
          <p:cNvPr id="13340" name="TextBox 22"/>
          <p:cNvSpPr txBox="1">
            <a:spLocks noChangeArrowheads="1"/>
          </p:cNvSpPr>
          <p:nvPr/>
        </p:nvSpPr>
        <p:spPr bwMode="auto">
          <a:xfrm rot="16200000">
            <a:off x="2315434" y="2659486"/>
            <a:ext cx="633842" cy="198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dirty="0">
                <a:latin typeface="Calibri" pitchFamily="-72" charset="0"/>
              </a:rPr>
              <a:t>DAPI</a:t>
            </a:r>
          </a:p>
        </p:txBody>
      </p:sp>
      <p:sp>
        <p:nvSpPr>
          <p:cNvPr id="13341" name="TextBox 16"/>
          <p:cNvSpPr txBox="1">
            <a:spLocks noChangeArrowheads="1"/>
          </p:cNvSpPr>
          <p:nvPr/>
        </p:nvSpPr>
        <p:spPr bwMode="auto">
          <a:xfrm>
            <a:off x="3117031" y="650386"/>
            <a:ext cx="528871" cy="3382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>
                <a:ea typeface="Arial" pitchFamily="-72" charset="0"/>
                <a:cs typeface="Arial" pitchFamily="-72" charset="0"/>
              </a:rPr>
              <a:t>Paired</a:t>
            </a:r>
          </a:p>
        </p:txBody>
      </p:sp>
      <p:pic>
        <p:nvPicPr>
          <p:cNvPr id="13338" name="Picture 7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 flipH="1">
            <a:off x="2781888" y="941860"/>
            <a:ext cx="2802465" cy="2415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42" name="TextBox 24"/>
          <p:cNvSpPr txBox="1">
            <a:spLocks noChangeArrowheads="1"/>
          </p:cNvSpPr>
          <p:nvPr/>
        </p:nvSpPr>
        <p:spPr bwMode="auto">
          <a:xfrm>
            <a:off x="4269534" y="650386"/>
            <a:ext cx="826442" cy="3382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>
                <a:ea typeface="Arial" pitchFamily="-72" charset="0"/>
                <a:cs typeface="Arial" pitchFamily="-72" charset="0"/>
              </a:rPr>
              <a:t>Non-paired</a:t>
            </a:r>
          </a:p>
        </p:txBody>
      </p:sp>
      <p:sp>
        <p:nvSpPr>
          <p:cNvPr id="13318" name="TextBox 47"/>
          <p:cNvSpPr txBox="1">
            <a:spLocks noChangeArrowheads="1"/>
          </p:cNvSpPr>
          <p:nvPr/>
        </p:nvSpPr>
        <p:spPr bwMode="auto">
          <a:xfrm>
            <a:off x="2415612" y="658788"/>
            <a:ext cx="38985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2400" dirty="0" smtClean="0">
                <a:ea typeface="Arial" pitchFamily="-72" charset="0"/>
                <a:cs typeface="Arial" pitchFamily="-72" charset="0"/>
              </a:rPr>
              <a:t>A</a:t>
            </a:r>
            <a:endParaRPr lang="en-US" sz="2400" dirty="0">
              <a:ea typeface="Arial" pitchFamily="-72" charset="0"/>
              <a:cs typeface="Arial" pitchFamily="-72" charset="0"/>
            </a:endParaRPr>
          </a:p>
        </p:txBody>
      </p:sp>
      <p:sp>
        <p:nvSpPr>
          <p:cNvPr id="13347" name="TextBox 7"/>
          <p:cNvSpPr txBox="1">
            <a:spLocks noChangeArrowheads="1"/>
          </p:cNvSpPr>
          <p:nvPr/>
        </p:nvSpPr>
        <p:spPr bwMode="auto">
          <a:xfrm rot="2505404">
            <a:off x="2714002" y="6085716"/>
            <a:ext cx="145905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b="1" dirty="0" err="1">
                <a:ea typeface="Arial" pitchFamily="-72" charset="0"/>
                <a:cs typeface="Arial" pitchFamily="-72" charset="0"/>
              </a:rPr>
              <a:t>Spermatogonia</a:t>
            </a:r>
            <a:r>
              <a:rPr lang="en-US" sz="1200" b="1" dirty="0">
                <a:ea typeface="Arial" pitchFamily="-72" charset="0"/>
                <a:cs typeface="Arial" pitchFamily="-72" charset="0"/>
              </a:rPr>
              <a:t> B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5814943" y="1108258"/>
            <a:ext cx="1195834" cy="2082336"/>
            <a:chOff x="5814943" y="1108258"/>
            <a:chExt cx="1195834" cy="2082336"/>
          </a:xfrm>
        </p:grpSpPr>
        <p:grpSp>
          <p:nvGrpSpPr>
            <p:cNvPr id="12" name="Group 11"/>
            <p:cNvGrpSpPr/>
            <p:nvPr/>
          </p:nvGrpSpPr>
          <p:grpSpPr>
            <a:xfrm>
              <a:off x="5814943" y="1108258"/>
              <a:ext cx="1195834" cy="2082336"/>
              <a:chOff x="4923934" y="1100623"/>
              <a:chExt cx="1195834" cy="2082336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23934" y="1212840"/>
                <a:ext cx="479333" cy="197011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7" name="Straight Arrow Connector 6"/>
              <p:cNvCxnSpPr/>
              <p:nvPr/>
            </p:nvCxnSpPr>
            <p:spPr>
              <a:xfrm flipH="1">
                <a:off x="5204264" y="1279811"/>
                <a:ext cx="168874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5293901" y="1100623"/>
                <a:ext cx="8258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Centromere </a:t>
                </a:r>
              </a:p>
              <a:p>
                <a:r>
                  <a:rPr lang="en-US" sz="900" dirty="0" smtClean="0"/>
                  <a:t>DNA probe</a:t>
                </a:r>
                <a:endParaRPr lang="en-US" sz="900" dirty="0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 rot="5400000">
              <a:off x="5707256" y="2123755"/>
              <a:ext cx="14510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Chromosome VIII</a:t>
              </a:r>
              <a:endParaRPr lang="en-US" sz="1200" b="1" dirty="0"/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1854830" y="3501008"/>
            <a:ext cx="6039692" cy="2806161"/>
            <a:chOff x="1854830" y="3501008"/>
            <a:chExt cx="6039692" cy="2806161"/>
          </a:xfrm>
        </p:grpSpPr>
        <p:sp>
          <p:nvSpPr>
            <p:cNvPr id="13344" name="TextBox 3"/>
            <p:cNvSpPr txBox="1">
              <a:spLocks noChangeArrowheads="1"/>
            </p:cNvSpPr>
            <p:nvPr/>
          </p:nvSpPr>
          <p:spPr bwMode="auto">
            <a:xfrm>
              <a:off x="2424483" y="5681876"/>
              <a:ext cx="29848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ea typeface="Arial" pitchFamily="-72" charset="0"/>
                  <a:cs typeface="Arial" pitchFamily="-72" charset="0"/>
                </a:rPr>
                <a:t>0</a:t>
              </a:r>
            </a:p>
          </p:txBody>
        </p:sp>
        <p:sp>
          <p:nvSpPr>
            <p:cNvPr id="13345" name="TextBox 5"/>
            <p:cNvSpPr txBox="1">
              <a:spLocks noChangeArrowheads="1"/>
            </p:cNvSpPr>
            <p:nvPr/>
          </p:nvSpPr>
          <p:spPr bwMode="auto">
            <a:xfrm>
              <a:off x="2358565" y="5186797"/>
              <a:ext cx="41229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ea typeface="Arial" pitchFamily="-72" charset="0"/>
                  <a:cs typeface="Arial" pitchFamily="-72" charset="0"/>
                </a:rPr>
                <a:t>2</a:t>
              </a:r>
              <a:r>
                <a:rPr lang="en-US" sz="1600" b="1" dirty="0" smtClean="0">
                  <a:ea typeface="Arial" pitchFamily="-72" charset="0"/>
                  <a:cs typeface="Arial" pitchFamily="-72" charset="0"/>
                </a:rPr>
                <a:t>0</a:t>
              </a:r>
              <a:endParaRPr lang="en-US" sz="1600" b="1" dirty="0">
                <a:ea typeface="Arial" pitchFamily="-72" charset="0"/>
                <a:cs typeface="Arial" pitchFamily="-72" charset="0"/>
              </a:endParaRPr>
            </a:p>
          </p:txBody>
        </p:sp>
        <p:sp>
          <p:nvSpPr>
            <p:cNvPr id="13346" name="TextBox 6"/>
            <p:cNvSpPr txBox="1">
              <a:spLocks noChangeArrowheads="1"/>
            </p:cNvSpPr>
            <p:nvPr/>
          </p:nvSpPr>
          <p:spPr bwMode="auto">
            <a:xfrm>
              <a:off x="2234956" y="3680461"/>
              <a:ext cx="526107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ea typeface="Arial" pitchFamily="-72" charset="0"/>
                  <a:cs typeface="Arial" pitchFamily="-72" charset="0"/>
                </a:rPr>
                <a:t>100</a:t>
              </a:r>
            </a:p>
          </p:txBody>
        </p:sp>
        <p:sp>
          <p:nvSpPr>
            <p:cNvPr id="13348" name="TextBox 9"/>
            <p:cNvSpPr txBox="1">
              <a:spLocks noChangeArrowheads="1"/>
            </p:cNvSpPr>
            <p:nvPr/>
          </p:nvSpPr>
          <p:spPr bwMode="auto">
            <a:xfrm rot="2505404">
              <a:off x="3365882" y="6006800"/>
              <a:ext cx="116730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>
                  <a:ea typeface="Arial" pitchFamily="-72" charset="0"/>
                  <a:cs typeface="Arial" pitchFamily="-72" charset="0"/>
                </a:rPr>
                <a:t>Pre-leptotene</a:t>
              </a:r>
            </a:p>
          </p:txBody>
        </p:sp>
        <p:sp>
          <p:nvSpPr>
            <p:cNvPr id="13349" name="TextBox 10"/>
            <p:cNvSpPr txBox="1">
              <a:spLocks noChangeArrowheads="1"/>
            </p:cNvSpPr>
            <p:nvPr/>
          </p:nvSpPr>
          <p:spPr bwMode="auto">
            <a:xfrm rot="2505404">
              <a:off x="5157389" y="5935195"/>
              <a:ext cx="95250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>
                  <a:ea typeface="Arial" pitchFamily="-72" charset="0"/>
                  <a:cs typeface="Arial" pitchFamily="-72" charset="0"/>
                </a:rPr>
                <a:t>Pachytene</a:t>
              </a:r>
            </a:p>
          </p:txBody>
        </p:sp>
        <p:sp>
          <p:nvSpPr>
            <p:cNvPr id="13350" name="TextBox 11"/>
            <p:cNvSpPr txBox="1">
              <a:spLocks noChangeArrowheads="1"/>
            </p:cNvSpPr>
            <p:nvPr/>
          </p:nvSpPr>
          <p:spPr bwMode="auto">
            <a:xfrm rot="2505404">
              <a:off x="6330635" y="6030170"/>
              <a:ext cx="123783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>
                  <a:ea typeface="Arial" pitchFamily="-72" charset="0"/>
                  <a:cs typeface="Arial" pitchFamily="-72" charset="0"/>
                </a:rPr>
                <a:t>Late-diplotene</a:t>
              </a:r>
            </a:p>
          </p:txBody>
        </p:sp>
        <p:sp>
          <p:nvSpPr>
            <p:cNvPr id="13351" name="TextBox 12"/>
            <p:cNvSpPr txBox="1">
              <a:spLocks noChangeArrowheads="1"/>
            </p:cNvSpPr>
            <p:nvPr/>
          </p:nvSpPr>
          <p:spPr bwMode="auto">
            <a:xfrm rot="2505404">
              <a:off x="5729945" y="6016519"/>
              <a:ext cx="118814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smtClean="0">
                  <a:ea typeface="Arial" pitchFamily="-72" charset="0"/>
                  <a:cs typeface="Arial" pitchFamily="-72" charset="0"/>
                </a:rPr>
                <a:t>Mid-diplotene</a:t>
              </a:r>
              <a:endParaRPr lang="en-US" sz="1200" b="1" dirty="0">
                <a:ea typeface="Arial" pitchFamily="-72" charset="0"/>
                <a:cs typeface="Arial" pitchFamily="-72" charset="0"/>
              </a:endParaRPr>
            </a:p>
          </p:txBody>
        </p:sp>
        <p:sp>
          <p:nvSpPr>
            <p:cNvPr id="13352" name="TextBox 1"/>
            <p:cNvSpPr txBox="1">
              <a:spLocks noChangeArrowheads="1"/>
            </p:cNvSpPr>
            <p:nvPr/>
          </p:nvSpPr>
          <p:spPr bwMode="auto">
            <a:xfrm rot="16200000">
              <a:off x="1107659" y="4593233"/>
              <a:ext cx="2079118" cy="5847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n-US" sz="1600" b="1" dirty="0">
                  <a:ea typeface="Arial" pitchFamily="-72" charset="0"/>
                  <a:cs typeface="Arial" pitchFamily="-72" charset="0"/>
                </a:rPr>
                <a:t>% </a:t>
              </a:r>
              <a:r>
                <a:rPr lang="en-US" sz="1600" b="1" dirty="0" smtClean="0">
                  <a:ea typeface="Arial" pitchFamily="-72" charset="0"/>
                  <a:cs typeface="Arial" pitchFamily="-72" charset="0"/>
                </a:rPr>
                <a:t>Homologous</a:t>
              </a:r>
            </a:p>
            <a:p>
              <a:pPr algn="ctr"/>
              <a:r>
                <a:rPr lang="en-US" sz="1600" b="1" dirty="0" smtClean="0">
                  <a:ea typeface="Arial" pitchFamily="-72" charset="0"/>
                  <a:cs typeface="Arial" pitchFamily="-72" charset="0"/>
                </a:rPr>
                <a:t> </a:t>
              </a:r>
              <a:r>
                <a:rPr lang="en-US" sz="1600" b="1" dirty="0">
                  <a:ea typeface="Arial" pitchFamily="-72" charset="0"/>
                  <a:cs typeface="Arial" pitchFamily="-72" charset="0"/>
                </a:rPr>
                <a:t>pairing</a:t>
              </a:r>
            </a:p>
          </p:txBody>
        </p:sp>
        <p:sp>
          <p:nvSpPr>
            <p:cNvPr id="43" name="TextBox 47"/>
            <p:cNvSpPr txBox="1">
              <a:spLocks noChangeArrowheads="1"/>
            </p:cNvSpPr>
            <p:nvPr/>
          </p:nvSpPr>
          <p:spPr bwMode="auto">
            <a:xfrm>
              <a:off x="1983564" y="3501008"/>
              <a:ext cx="389850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2400" dirty="0" smtClean="0">
                  <a:ea typeface="Arial" pitchFamily="-72" charset="0"/>
                  <a:cs typeface="Arial" pitchFamily="-72" charset="0"/>
                </a:rPr>
                <a:t>B</a:t>
              </a:r>
              <a:endParaRPr lang="en-US" sz="2400" dirty="0">
                <a:ea typeface="Arial" pitchFamily="-72" charset="0"/>
                <a:cs typeface="Arial" pitchFamily="-72" charset="0"/>
              </a:endParaRPr>
            </a:p>
          </p:txBody>
        </p:sp>
        <p:sp>
          <p:nvSpPr>
            <p:cNvPr id="48" name="TextBox 10"/>
            <p:cNvSpPr txBox="1">
              <a:spLocks noChangeArrowheads="1"/>
            </p:cNvSpPr>
            <p:nvPr/>
          </p:nvSpPr>
          <p:spPr bwMode="auto">
            <a:xfrm rot="2505404">
              <a:off x="3993977" y="5920243"/>
              <a:ext cx="92044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smtClean="0">
                  <a:ea typeface="Arial" pitchFamily="-72" charset="0"/>
                  <a:cs typeface="Arial" pitchFamily="-72" charset="0"/>
                </a:rPr>
                <a:t>Leptotene</a:t>
              </a:r>
              <a:endParaRPr lang="en-US" sz="1200" b="1" dirty="0">
                <a:ea typeface="Arial" pitchFamily="-72" charset="0"/>
                <a:cs typeface="Arial" pitchFamily="-72" charset="0"/>
              </a:endParaRPr>
            </a:p>
          </p:txBody>
        </p:sp>
        <p:sp>
          <p:nvSpPr>
            <p:cNvPr id="49" name="TextBox 10"/>
            <p:cNvSpPr txBox="1">
              <a:spLocks noChangeArrowheads="1"/>
            </p:cNvSpPr>
            <p:nvPr/>
          </p:nvSpPr>
          <p:spPr bwMode="auto">
            <a:xfrm rot="2505404">
              <a:off x="4595108" y="5915369"/>
              <a:ext cx="86914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smtClean="0">
                  <a:ea typeface="Arial" pitchFamily="-72" charset="0"/>
                  <a:cs typeface="Arial" pitchFamily="-72" charset="0"/>
                </a:rPr>
                <a:t>Zygotene</a:t>
              </a:r>
              <a:endParaRPr lang="en-US" sz="1200" b="1" dirty="0">
                <a:ea typeface="Arial" pitchFamily="-72" charset="0"/>
                <a:cs typeface="Arial" pitchFamily="-72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37" t="15258" r="4123" b="11427"/>
            <a:stretch/>
          </p:blipFill>
          <p:spPr bwMode="auto">
            <a:xfrm>
              <a:off x="2664335" y="3680461"/>
              <a:ext cx="4174579" cy="20887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6" name="TextBox 5"/>
            <p:cNvSpPr txBox="1">
              <a:spLocks noChangeArrowheads="1"/>
            </p:cNvSpPr>
            <p:nvPr/>
          </p:nvSpPr>
          <p:spPr bwMode="auto">
            <a:xfrm>
              <a:off x="2367577" y="4733050"/>
              <a:ext cx="41229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ea typeface="Arial" pitchFamily="-72" charset="0"/>
                  <a:cs typeface="Arial" pitchFamily="-72" charset="0"/>
                </a:rPr>
                <a:t>4</a:t>
              </a:r>
              <a:r>
                <a:rPr lang="en-US" sz="1600" b="1" dirty="0" smtClean="0">
                  <a:ea typeface="Arial" pitchFamily="-72" charset="0"/>
                  <a:cs typeface="Arial" pitchFamily="-72" charset="0"/>
                </a:rPr>
                <a:t>0</a:t>
              </a:r>
              <a:endParaRPr lang="en-US" sz="1600" b="1" dirty="0">
                <a:ea typeface="Arial" pitchFamily="-72" charset="0"/>
                <a:cs typeface="Arial" pitchFamily="-72" charset="0"/>
              </a:endParaRPr>
            </a:p>
          </p:txBody>
        </p:sp>
        <p:sp>
          <p:nvSpPr>
            <p:cNvPr id="47" name="TextBox 5"/>
            <p:cNvSpPr txBox="1">
              <a:spLocks noChangeArrowheads="1"/>
            </p:cNvSpPr>
            <p:nvPr/>
          </p:nvSpPr>
          <p:spPr bwMode="auto">
            <a:xfrm>
              <a:off x="2340441" y="4389299"/>
              <a:ext cx="41229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ea typeface="Arial" pitchFamily="-72" charset="0"/>
                  <a:cs typeface="Arial" pitchFamily="-72" charset="0"/>
                </a:rPr>
                <a:t>6</a:t>
              </a:r>
              <a:r>
                <a:rPr lang="en-US" sz="1600" b="1" dirty="0" smtClean="0">
                  <a:ea typeface="Arial" pitchFamily="-72" charset="0"/>
                  <a:cs typeface="Arial" pitchFamily="-72" charset="0"/>
                </a:rPr>
                <a:t>0</a:t>
              </a:r>
              <a:endParaRPr lang="en-US" sz="1600" b="1" dirty="0">
                <a:ea typeface="Arial" pitchFamily="-72" charset="0"/>
                <a:cs typeface="Arial" pitchFamily="-72" charset="0"/>
              </a:endParaRPr>
            </a:p>
          </p:txBody>
        </p:sp>
        <p:sp>
          <p:nvSpPr>
            <p:cNvPr id="50" name="TextBox 5"/>
            <p:cNvSpPr txBox="1">
              <a:spLocks noChangeArrowheads="1"/>
            </p:cNvSpPr>
            <p:nvPr/>
          </p:nvSpPr>
          <p:spPr bwMode="auto">
            <a:xfrm>
              <a:off x="2288673" y="4019015"/>
              <a:ext cx="41229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600" b="1" dirty="0">
                  <a:ea typeface="Arial" pitchFamily="-72" charset="0"/>
                  <a:cs typeface="Arial" pitchFamily="-72" charset="0"/>
                </a:rPr>
                <a:t>8</a:t>
              </a:r>
              <a:r>
                <a:rPr lang="en-US" sz="1600" b="1" dirty="0" smtClean="0">
                  <a:ea typeface="Arial" pitchFamily="-72" charset="0"/>
                  <a:cs typeface="Arial" pitchFamily="-72" charset="0"/>
                </a:rPr>
                <a:t>0</a:t>
              </a:r>
              <a:endParaRPr lang="en-US" sz="1600" b="1" dirty="0">
                <a:ea typeface="Arial" pitchFamily="-72" charset="0"/>
                <a:cs typeface="Arial" pitchFamily="-72" charset="0"/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6838914" y="5754909"/>
              <a:ext cx="46939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4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63" t="78515" r="69858" b="11427"/>
            <a:stretch/>
          </p:blipFill>
          <p:spPr bwMode="auto">
            <a:xfrm>
              <a:off x="7054176" y="5356074"/>
              <a:ext cx="235536" cy="4093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" name="TextBox 10"/>
            <p:cNvSpPr txBox="1">
              <a:spLocks noChangeArrowheads="1"/>
            </p:cNvSpPr>
            <p:nvPr/>
          </p:nvSpPr>
          <p:spPr bwMode="auto">
            <a:xfrm rot="2505404">
              <a:off x="6966063" y="5901854"/>
              <a:ext cx="92845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err="1" smtClean="0">
                  <a:ea typeface="Arial" pitchFamily="-72" charset="0"/>
                  <a:cs typeface="Arial" pitchFamily="-72" charset="0"/>
                </a:rPr>
                <a:t>diakinesis</a:t>
              </a:r>
              <a:endParaRPr lang="en-US" sz="1200" b="1" dirty="0">
                <a:ea typeface="Arial" pitchFamily="-72" charset="0"/>
                <a:cs typeface="Arial" pitchFamily="-72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09</TotalTime>
  <Words>30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Pezza, PhD</dc:creator>
  <cp:lastModifiedBy>Roberto Pezza, PhD</cp:lastModifiedBy>
  <cp:revision>65</cp:revision>
  <cp:lastPrinted>2011-12-20T16:14:52Z</cp:lastPrinted>
  <dcterms:created xsi:type="dcterms:W3CDTF">2011-06-13T14:28:59Z</dcterms:created>
  <dcterms:modified xsi:type="dcterms:W3CDTF">2012-04-18T22:43:38Z</dcterms:modified>
</cp:coreProperties>
</file>